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5746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9285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716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8650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364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9665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5105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1653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0853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7454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3589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C6F90-14AE-4024-A312-B173B34B11A0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4126A-0652-4CD7-8D5E-9CB708652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8013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5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9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181049" y="1298747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924312" y="2084651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420466" y="1693200"/>
            <a:ext cx="4283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8226910"/>
              </p:ext>
            </p:extLst>
          </p:nvPr>
        </p:nvGraphicFramePr>
        <p:xfrm>
          <a:off x="3792878" y="1472792"/>
          <a:ext cx="1058400" cy="365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200">
                  <a:extLst>
                    <a:ext uri="{9D8B030D-6E8A-4147-A177-3AD203B41FA5}">
                      <a16:colId xmlns:a16="http://schemas.microsoft.com/office/drawing/2014/main" val="929517153"/>
                    </a:ext>
                  </a:extLst>
                </a:gridCol>
                <a:gridCol w="151200">
                  <a:extLst>
                    <a:ext uri="{9D8B030D-6E8A-4147-A177-3AD203B41FA5}">
                      <a16:colId xmlns:a16="http://schemas.microsoft.com/office/drawing/2014/main" val="3118574558"/>
                    </a:ext>
                  </a:extLst>
                </a:gridCol>
                <a:gridCol w="151200">
                  <a:extLst>
                    <a:ext uri="{9D8B030D-6E8A-4147-A177-3AD203B41FA5}">
                      <a16:colId xmlns:a16="http://schemas.microsoft.com/office/drawing/2014/main" val="2470206851"/>
                    </a:ext>
                  </a:extLst>
                </a:gridCol>
                <a:gridCol w="151200">
                  <a:extLst>
                    <a:ext uri="{9D8B030D-6E8A-4147-A177-3AD203B41FA5}">
                      <a16:colId xmlns:a16="http://schemas.microsoft.com/office/drawing/2014/main" val="1968127760"/>
                    </a:ext>
                  </a:extLst>
                </a:gridCol>
                <a:gridCol w="151200">
                  <a:extLst>
                    <a:ext uri="{9D8B030D-6E8A-4147-A177-3AD203B41FA5}">
                      <a16:colId xmlns:a16="http://schemas.microsoft.com/office/drawing/2014/main" val="2649790940"/>
                    </a:ext>
                  </a:extLst>
                </a:gridCol>
                <a:gridCol w="151200">
                  <a:extLst>
                    <a:ext uri="{9D8B030D-6E8A-4147-A177-3AD203B41FA5}">
                      <a16:colId xmlns:a16="http://schemas.microsoft.com/office/drawing/2014/main" val="479234651"/>
                    </a:ext>
                  </a:extLst>
                </a:gridCol>
                <a:gridCol w="151200">
                  <a:extLst>
                    <a:ext uri="{9D8B030D-6E8A-4147-A177-3AD203B41FA5}">
                      <a16:colId xmlns:a16="http://schemas.microsoft.com/office/drawing/2014/main" val="3177813033"/>
                    </a:ext>
                  </a:extLst>
                </a:gridCol>
              </a:tblGrid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701135"/>
                  </a:ext>
                </a:extLst>
              </a:tr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4845894"/>
                  </a:ext>
                </a:extLst>
              </a:tr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7735603"/>
                  </a:ext>
                </a:extLst>
              </a:tr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8494252"/>
                  </a:ext>
                </a:extLst>
              </a:tr>
            </a:tbl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4787182" y="1407042"/>
            <a:ext cx="6303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4785879" y="1500235"/>
            <a:ext cx="8739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785879" y="1603695"/>
            <a:ext cx="8931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782656" y="1687058"/>
            <a:ext cx="7729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µM Nec-1s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923151" y="1796370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589149" y="18051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85" t="24805" r="34984" b="65280"/>
          <a:stretch/>
        </p:blipFill>
        <p:spPr>
          <a:xfrm>
            <a:off x="3793815" y="1951049"/>
            <a:ext cx="1058400" cy="2160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feld 14"/>
          <p:cNvSpPr txBox="1"/>
          <p:nvPr/>
        </p:nvSpPr>
        <p:spPr>
          <a:xfrm>
            <a:off x="4924312" y="1939384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590310" y="19203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mit Pfeil 16"/>
          <p:cNvCxnSpPr/>
          <p:nvPr/>
        </p:nvCxnSpPr>
        <p:spPr>
          <a:xfrm flipH="1">
            <a:off x="4860177" y="203183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4860177" y="189102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/>
          <p:cNvSpPr txBox="1"/>
          <p:nvPr/>
        </p:nvSpPr>
        <p:spPr>
          <a:xfrm>
            <a:off x="3124490" y="12657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9" t="35179" r="36360" b="59597"/>
          <a:stretch/>
        </p:blipFill>
        <p:spPr>
          <a:xfrm>
            <a:off x="3793815" y="1844168"/>
            <a:ext cx="1058400" cy="1138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feld 20"/>
          <p:cNvSpPr txBox="1"/>
          <p:nvPr/>
        </p:nvSpPr>
        <p:spPr>
          <a:xfrm>
            <a:off x="3590310" y="21291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4928604" y="2358701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594602" y="23766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1" t="40310" r="35399" b="49777"/>
          <a:stretch/>
        </p:blipFill>
        <p:spPr>
          <a:xfrm>
            <a:off x="3793815" y="2209715"/>
            <a:ext cx="1058400" cy="2160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feld 24"/>
          <p:cNvSpPr txBox="1"/>
          <p:nvPr/>
        </p:nvSpPr>
        <p:spPr>
          <a:xfrm>
            <a:off x="4923217" y="2216456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589215" y="22430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85" t="31300" r="34984" b="63344"/>
          <a:stretch/>
        </p:blipFill>
        <p:spPr>
          <a:xfrm>
            <a:off x="3793815" y="2533977"/>
            <a:ext cx="1058400" cy="116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feld 27"/>
          <p:cNvSpPr txBox="1"/>
          <p:nvPr/>
        </p:nvSpPr>
        <p:spPr>
          <a:xfrm>
            <a:off x="4921706" y="2467144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582966" y="25093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83" t="38688" r="36086" b="55956"/>
          <a:stretch/>
        </p:blipFill>
        <p:spPr>
          <a:xfrm>
            <a:off x="3793815" y="2657547"/>
            <a:ext cx="1058400" cy="116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feld 30"/>
          <p:cNvSpPr txBox="1"/>
          <p:nvPr/>
        </p:nvSpPr>
        <p:spPr>
          <a:xfrm>
            <a:off x="3582966" y="26391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4921706" y="2585317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 flipH="1">
            <a:off x="4860177" y="231245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/>
          <p:cNvCxnSpPr/>
          <p:nvPr/>
        </p:nvCxnSpPr>
        <p:spPr>
          <a:xfrm flipH="1">
            <a:off x="4860177" y="246538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/>
          <p:cNvCxnSpPr/>
          <p:nvPr/>
        </p:nvCxnSpPr>
        <p:spPr>
          <a:xfrm flipH="1">
            <a:off x="4860177" y="218003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flipH="1">
            <a:off x="4860177" y="269109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/>
          <p:cNvCxnSpPr/>
          <p:nvPr/>
        </p:nvCxnSpPr>
        <p:spPr>
          <a:xfrm flipH="1">
            <a:off x="4860177" y="257017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54" t="38872" r="38015" b="55732"/>
          <a:stretch/>
        </p:blipFill>
        <p:spPr>
          <a:xfrm>
            <a:off x="3793815" y="2142762"/>
            <a:ext cx="1058400" cy="1175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2" t="35548" r="35398" b="58911"/>
          <a:stretch/>
        </p:blipFill>
        <p:spPr>
          <a:xfrm>
            <a:off x="3793815" y="2406544"/>
            <a:ext cx="1058400" cy="12073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00743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1634385" y="175039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00383" y="1838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85" t="24805" r="34984" b="65280"/>
          <a:stretch/>
        </p:blipFill>
        <p:spPr>
          <a:xfrm>
            <a:off x="6652276" y="183819"/>
            <a:ext cx="1058400" cy="2160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feld 12"/>
          <p:cNvSpPr txBox="1"/>
          <p:nvPr/>
        </p:nvSpPr>
        <p:spPr>
          <a:xfrm>
            <a:off x="7782773" y="172154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6448771" y="1531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Gerade Verbindung mit Pfeil 14"/>
          <p:cNvCxnSpPr/>
          <p:nvPr/>
        </p:nvCxnSpPr>
        <p:spPr>
          <a:xfrm flipH="1">
            <a:off x="7718638" y="26460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flipH="1">
            <a:off x="1571411" y="2696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9" t="35179" r="36360" b="59597"/>
          <a:stretch/>
        </p:blipFill>
        <p:spPr>
          <a:xfrm>
            <a:off x="505049" y="222837"/>
            <a:ext cx="1058400" cy="1138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17" t="15047" r="22311" b="17910"/>
          <a:stretch/>
        </p:blipFill>
        <p:spPr>
          <a:xfrm>
            <a:off x="435997" y="583276"/>
            <a:ext cx="3250346" cy="2789304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8" t="6367" r="23413" b="19018"/>
          <a:stretch/>
        </p:blipFill>
        <p:spPr>
          <a:xfrm>
            <a:off x="215154" y="3619180"/>
            <a:ext cx="3880436" cy="3104350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484" b="26221"/>
          <a:stretch/>
        </p:blipFill>
        <p:spPr>
          <a:xfrm>
            <a:off x="4318811" y="3619180"/>
            <a:ext cx="4379515" cy="3069579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35" t="8584" r="22311" b="29361"/>
          <a:stretch/>
        </p:blipFill>
        <p:spPr>
          <a:xfrm>
            <a:off x="5254269" y="492297"/>
            <a:ext cx="3104350" cy="2581836"/>
          </a:xfrm>
          <a:prstGeom prst="rect">
            <a:avLst/>
          </a:prstGeom>
        </p:spPr>
      </p:pic>
      <p:sp>
        <p:nvSpPr>
          <p:cNvPr id="43" name="Rechteck 42"/>
          <p:cNvSpPr/>
          <p:nvPr/>
        </p:nvSpPr>
        <p:spPr>
          <a:xfrm>
            <a:off x="300383" y="390427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300383" y="45329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300383" y="46203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300383" y="47117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300383" y="48123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300383" y="49975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300383" y="52099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300383" y="56125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300383" y="59039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300383" y="61139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300383" y="63616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300383" y="43728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990868" y="430060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6" name="Rechteck 55"/>
          <p:cNvSpPr/>
          <p:nvPr/>
        </p:nvSpPr>
        <p:spPr>
          <a:xfrm>
            <a:off x="828128" y="1438787"/>
            <a:ext cx="2076438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7" name="Rechteck 56"/>
          <p:cNvSpPr/>
          <p:nvPr/>
        </p:nvSpPr>
        <p:spPr>
          <a:xfrm>
            <a:off x="4902547" y="390427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4902547" y="45329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4902547" y="46203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4902547" y="47117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4902547" y="48123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4902547" y="49975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4902547" y="52099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4902547" y="56125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4902547" y="59039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4902547" y="61139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4902547" y="63616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4902547" y="43728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5593032" y="430060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0" name="Rechteck 69"/>
          <p:cNvSpPr/>
          <p:nvPr/>
        </p:nvSpPr>
        <p:spPr>
          <a:xfrm>
            <a:off x="5614057" y="1271692"/>
            <a:ext cx="2076438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49116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319426" y="94486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985424" y="1390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1" t="40310" r="35399" b="49777"/>
          <a:stretch/>
        </p:blipFill>
        <p:spPr>
          <a:xfrm>
            <a:off x="6291128" y="162148"/>
            <a:ext cx="1058400" cy="2160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7420530" y="168889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6086528" y="1954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Gerade Verbindung mit Pfeil 14"/>
          <p:cNvCxnSpPr/>
          <p:nvPr/>
        </p:nvCxnSpPr>
        <p:spPr>
          <a:xfrm flipH="1">
            <a:off x="7357490" y="26488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 flipH="1">
            <a:off x="2255291" y="1898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54" t="38872" r="38015" b="55732"/>
          <a:stretch/>
        </p:blipFill>
        <p:spPr>
          <a:xfrm>
            <a:off x="1188929" y="152597"/>
            <a:ext cx="1058400" cy="1175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64" t="16525" r="23550" b="16987"/>
          <a:stretch/>
        </p:blipFill>
        <p:spPr>
          <a:xfrm>
            <a:off x="618592" y="448691"/>
            <a:ext cx="3273398" cy="2766252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616" b="18279"/>
          <a:stretch/>
        </p:blipFill>
        <p:spPr>
          <a:xfrm>
            <a:off x="180794" y="3429000"/>
            <a:ext cx="4148994" cy="3399993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2" t="7106" r="22586" b="14586"/>
          <a:stretch/>
        </p:blipFill>
        <p:spPr>
          <a:xfrm>
            <a:off x="4948518" y="3580759"/>
            <a:ext cx="4041802" cy="3258030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49" t="12462" r="25479" b="15325"/>
          <a:stretch/>
        </p:blipFill>
        <p:spPr>
          <a:xfrm>
            <a:off x="5195155" y="448691"/>
            <a:ext cx="3250346" cy="3004457"/>
          </a:xfrm>
          <a:prstGeom prst="rect">
            <a:avLst/>
          </a:prstGeom>
        </p:spPr>
      </p:pic>
      <p:sp>
        <p:nvSpPr>
          <p:cNvPr id="26" name="Rechteck 25"/>
          <p:cNvSpPr/>
          <p:nvPr/>
        </p:nvSpPr>
        <p:spPr>
          <a:xfrm>
            <a:off x="538588" y="403490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538588" y="46635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38588" y="47509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38588" y="48423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38588" y="49429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38588" y="512816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38588" y="53405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38588" y="57432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38588" y="60345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38588" y="62445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38588" y="64922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38588" y="45035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229073" y="443123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9" name="Rechteck 38"/>
          <p:cNvSpPr/>
          <p:nvPr/>
        </p:nvSpPr>
        <p:spPr>
          <a:xfrm>
            <a:off x="985424" y="1392703"/>
            <a:ext cx="2076438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" name="Rechteck 39"/>
          <p:cNvSpPr/>
          <p:nvPr/>
        </p:nvSpPr>
        <p:spPr>
          <a:xfrm>
            <a:off x="5232321" y="403490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32321" y="46635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32321" y="47509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32321" y="48423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32321" y="49429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232321" y="512816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232321" y="53405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32321" y="57432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32321" y="60345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232321" y="62445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232321" y="64922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232321" y="45035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5922806" y="443123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3" name="Rechteck 52"/>
          <p:cNvSpPr/>
          <p:nvPr/>
        </p:nvSpPr>
        <p:spPr>
          <a:xfrm>
            <a:off x="5840171" y="1710021"/>
            <a:ext cx="2076438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81450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323718" y="36853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989716" y="3864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85" t="31300" r="34984" b="63344"/>
          <a:stretch/>
        </p:blipFill>
        <p:spPr>
          <a:xfrm>
            <a:off x="6529332" y="393197"/>
            <a:ext cx="1058400" cy="116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7657223" y="326364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6318483" y="3685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Gerade Verbindung mit Pfeil 9"/>
          <p:cNvCxnSpPr/>
          <p:nvPr/>
        </p:nvCxnSpPr>
        <p:spPr>
          <a:xfrm flipH="1">
            <a:off x="2255291" y="47521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7595694" y="42939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2" t="35548" r="35398" b="58911"/>
          <a:stretch/>
        </p:blipFill>
        <p:spPr>
          <a:xfrm>
            <a:off x="1188929" y="416379"/>
            <a:ext cx="1058400" cy="120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586" b="23636"/>
          <a:stretch/>
        </p:blipFill>
        <p:spPr>
          <a:xfrm>
            <a:off x="307745" y="3626166"/>
            <a:ext cx="4318043" cy="3177156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70" t="14309" r="22448" b="18834"/>
          <a:stretch/>
        </p:blipFill>
        <p:spPr>
          <a:xfrm>
            <a:off x="414938" y="659881"/>
            <a:ext cx="3150454" cy="278162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724" b="26406"/>
          <a:stretch/>
        </p:blipFill>
        <p:spPr>
          <a:xfrm>
            <a:off x="4726065" y="3626166"/>
            <a:ext cx="4310359" cy="3061895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99" t="9322" r="22173" b="29731"/>
          <a:stretch/>
        </p:blipFill>
        <p:spPr>
          <a:xfrm>
            <a:off x="5586292" y="656237"/>
            <a:ext cx="3058246" cy="2535731"/>
          </a:xfrm>
          <a:prstGeom prst="rect">
            <a:avLst/>
          </a:prstGeom>
        </p:spPr>
      </p:pic>
      <p:sp>
        <p:nvSpPr>
          <p:cNvPr id="18" name="Rechteck 17"/>
          <p:cNvSpPr/>
          <p:nvPr/>
        </p:nvSpPr>
        <p:spPr>
          <a:xfrm>
            <a:off x="884369" y="400843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884369" y="47129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884369" y="48003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884369" y="48917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884369" y="49924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884369" y="51775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884369" y="53899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884369" y="57926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884369" y="60839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884369" y="62939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884369" y="65417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884369" y="45529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574854" y="448065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1" name="Rechteck 30"/>
          <p:cNvSpPr/>
          <p:nvPr/>
        </p:nvSpPr>
        <p:spPr>
          <a:xfrm>
            <a:off x="833531" y="1542756"/>
            <a:ext cx="2076438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5316273" y="378562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316273" y="45686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316273" y="46561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316273" y="47474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316273" y="48481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316273" y="50333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316273" y="52457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316273" y="56483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316273" y="59397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316273" y="61496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316273" y="63974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316273" y="44086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6006758" y="433636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5" name="Rechteck 44"/>
          <p:cNvSpPr/>
          <p:nvPr/>
        </p:nvSpPr>
        <p:spPr>
          <a:xfrm>
            <a:off x="5897806" y="1564238"/>
            <a:ext cx="2076438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71800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83" t="38688" r="36086" b="55956"/>
          <a:stretch/>
        </p:blipFill>
        <p:spPr>
          <a:xfrm>
            <a:off x="1096721" y="290865"/>
            <a:ext cx="1058400" cy="116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885872" y="27242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2224612" y="218635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2163083" y="32441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101" b="24559"/>
          <a:stretch/>
        </p:blipFill>
        <p:spPr>
          <a:xfrm>
            <a:off x="281939" y="3377324"/>
            <a:ext cx="4233518" cy="3138736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9" t="14493" r="23688" b="26221"/>
          <a:stretch/>
        </p:blipFill>
        <p:spPr>
          <a:xfrm>
            <a:off x="345781" y="562871"/>
            <a:ext cx="3112033" cy="2466574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776793" y="371470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776793" y="44257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776793" y="45131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776793" y="46044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776793" y="47051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776793" y="48903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776793" y="51027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776793" y="55053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776793" y="57967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776793" y="60067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776793" y="62544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776793" y="42656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467278" y="419338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1" name="Rechteck 20"/>
          <p:cNvSpPr/>
          <p:nvPr/>
        </p:nvSpPr>
        <p:spPr>
          <a:xfrm>
            <a:off x="714435" y="1566989"/>
            <a:ext cx="2076438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5698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1</Words>
  <Application>Microsoft Office PowerPoint</Application>
  <PresentationFormat>Bildschirmpräsentation (4:3)</PresentationFormat>
  <Paragraphs>154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08-16T13:48:09Z</dcterms:created>
  <dcterms:modified xsi:type="dcterms:W3CDTF">2024-08-16T14:02:27Z</dcterms:modified>
</cp:coreProperties>
</file>